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D87DCE-F5D4-548C-6C8B-9BC41F7507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BC688F-2234-AB39-F853-A1FAD280C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923D4A-0F9D-00D3-A967-17824E28E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1ED14-8F20-BDAA-7C83-755086956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C66409-7236-2E04-A6A0-5E09061E0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785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196C2-12F3-46BE-910B-0FE8A5015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D786AD-4BE2-9502-CC52-1B2AD7649E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B8787A-BE7F-7EEB-ED00-F9435145A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F43B9-EC4E-2928-0493-B123EE482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4F7871-FA94-BB77-3A8D-A63FB4D14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669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BAA0CA-F7A2-46E6-55EE-08FEDD3B5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5FC1B9-3A99-CC50-F7AE-711016DD2C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6F56B-D4DE-6DDB-E348-4FE29D8E3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4C0F7-3747-A2D5-CC55-4F083515B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63E30-2A6D-36B7-1D84-0C0D3A8C5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196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839F9-AEE9-21C7-97D9-96C5AB90C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8582BD-7C6A-36EA-841F-D3474FFC7D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053393-3301-101C-41E7-F7E3EA872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9B0F6-E084-18E8-70A5-A4CB4AF24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E7AA17-213D-7CA1-00C3-28F05D176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740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CA6D2-743B-E067-C40C-56E16C59D6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BF160B-9AA5-37AE-6DC3-A1887689AA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1C3E61-9D30-954A-C745-B45F05A62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1E004E-83F9-2130-737F-F60450F07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29BB43-79AC-ABC7-277F-B20617AF4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4491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5C502-1AF3-DF29-231C-8FC9F5506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DF485F-CB12-EEE8-1A06-D4A8B04E7D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CDFA49-BFBD-0E41-6085-4360C37A18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899181-FB3F-2F47-13A8-952BF6EC4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DEAB10-6D10-6466-ABD2-02D7FAACB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5CA129-D950-1392-4B24-D49681AD4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664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66F80-3E76-5C72-9C89-3F1251BD1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7C4FE8-225A-C40E-C612-97753A0B7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900C13-8586-F496-FD11-4B7BFF11A9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A3EE70-62A9-F6FD-CBDF-2F885DF793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3F136F-8EB9-EA06-0592-DA26F02EB6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F34DD8-406D-5BBF-4994-DD3CF0F74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B16C0F-80DD-A715-CC4C-6BC4252B5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9B9714-FBFE-29FC-EF49-7300C48EA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14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007E8A-BE9D-0EEB-C8DD-E58338887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72E723-708C-52FD-E542-2A059C07B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E9D1E9-470C-6CC0-94AC-C0FA0C35A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FFD0F1-02B0-114D-4BCB-095235F42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099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371695-B184-2034-8887-8BDEC1EA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20C97D-3435-F803-90ED-EC9A717C9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307680-A650-922F-02F4-3ACD529FA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569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F497D-578B-21B0-E7B9-80982FD96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8E82D3-90F1-8CC2-A2A0-BE7111ACBD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43B2C-9E6B-F5E0-D919-AFC9B3E4F5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AFB971-3371-26D5-2B44-BBEAF871D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0F6B2-5DDD-EB7E-E9AD-BCFCBD182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618737-0A4E-68D1-9E68-F8DB77FB9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4264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95B88-87D4-AC06-B0FD-45B8D92FB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8DD2CC-4D71-C9F4-9434-36DACE6620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88569E-7D4E-885B-789B-D2A550F695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A9C02F-53F9-900E-EE1C-64BBD5F88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3F3FDC-DDF5-CE2D-9639-C5E7EBCF6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D81BFD-3E4A-9FEB-2BCD-19986B306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639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641C8B-3682-44E8-42AD-E27BA6D4E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36B8A-6241-1B6D-2932-C543369786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CD5451-E1B8-BE03-3A7D-EF76085511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C6D6E-F904-4A1F-BECD-6AC3FF685BCA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CD3B7B-D0FE-68C4-3F35-CA06A4D035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2EC26-39D8-0EA3-42F9-4F960CFF52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B218C-1C5E-4B1F-ACB1-38E5616E75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910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15A00A3-6D18-D138-8923-F4BE4743E6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341" y="235166"/>
            <a:ext cx="4178300" cy="33337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CC479DA-22DF-F007-895A-1BEE01C7DD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091"/>
          <a:stretch/>
        </p:blipFill>
        <p:spPr>
          <a:xfrm>
            <a:off x="633341" y="3355757"/>
            <a:ext cx="4159250" cy="293065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E5CF95C8-D1C0-29B4-4559-C8B7EDEBB9C3}"/>
              </a:ext>
            </a:extLst>
          </p:cNvPr>
          <p:cNvSpPr/>
          <p:nvPr/>
        </p:nvSpPr>
        <p:spPr>
          <a:xfrm>
            <a:off x="3145720" y="148698"/>
            <a:ext cx="1523939" cy="6629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7AD67E1-2F29-D4A1-DD89-6806410031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0616" y="254216"/>
            <a:ext cx="4076700" cy="32956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62CB505-0022-A24A-DD51-B39A816AA8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1075"/>
          <a:stretch/>
        </p:blipFill>
        <p:spPr>
          <a:xfrm>
            <a:off x="3316740" y="3389970"/>
            <a:ext cx="4076700" cy="2930651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7EE412C3-3E7D-5CAC-DCA2-E2A09CB10236}"/>
              </a:ext>
            </a:extLst>
          </p:cNvPr>
          <p:cNvSpPr/>
          <p:nvPr/>
        </p:nvSpPr>
        <p:spPr>
          <a:xfrm>
            <a:off x="6035943" y="182407"/>
            <a:ext cx="1523939" cy="6629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46DE5BD2-9F6C-0DF1-B23A-D09906B730C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554"/>
          <a:stretch/>
        </p:blipFill>
        <p:spPr>
          <a:xfrm>
            <a:off x="5637880" y="3355756"/>
            <a:ext cx="4076700" cy="296486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7E3D5F9-49D4-EE17-F15D-69DA9FDE2F1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37880" y="235166"/>
            <a:ext cx="4076700" cy="33147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ED11555-DB08-DEBD-77A1-93255DADBBC3}"/>
              </a:ext>
            </a:extLst>
          </p:cNvPr>
          <p:cNvSpPr/>
          <p:nvPr/>
        </p:nvSpPr>
        <p:spPr>
          <a:xfrm>
            <a:off x="100676" y="148698"/>
            <a:ext cx="10490384" cy="5260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4EA590-91EF-8E2A-6076-7F56C2D70872}"/>
              </a:ext>
            </a:extLst>
          </p:cNvPr>
          <p:cNvSpPr txBox="1"/>
          <p:nvPr/>
        </p:nvSpPr>
        <p:spPr>
          <a:xfrm>
            <a:off x="1623501" y="490037"/>
            <a:ext cx="5880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pCHK1</a:t>
            </a:r>
            <a:r>
              <a:rPr lang="en-GB" b="1" baseline="30000" dirty="0"/>
              <a:t>s345	</a:t>
            </a:r>
            <a:r>
              <a:rPr lang="en-GB" b="1" baseline="30000"/>
              <a:t>	</a:t>
            </a:r>
            <a:r>
              <a:rPr lang="en-GB" b="1"/>
              <a:t>c-PARP</a:t>
            </a:r>
            <a:r>
              <a:rPr lang="en-GB" b="1" dirty="0"/>
              <a:t>		</a:t>
            </a:r>
            <a:r>
              <a:rPr lang="en-GB" b="1"/>
              <a:t>      p</a:t>
            </a:r>
            <a:r>
              <a:rPr lang="en-GB" b="1">
                <a:latin typeface="Symbol" panose="05050102010706020507" pitchFamily="18" charset="2"/>
              </a:rPr>
              <a:t>g</a:t>
            </a:r>
            <a:r>
              <a:rPr lang="en-GB" b="1"/>
              <a:t>H2AX</a:t>
            </a:r>
            <a:endParaRPr lang="en-GB" b="1" baseline="30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0DEC7F6-DA3A-1952-6C8C-8A8CB991391D}"/>
              </a:ext>
            </a:extLst>
          </p:cNvPr>
          <p:cNvSpPr txBox="1"/>
          <p:nvPr/>
        </p:nvSpPr>
        <p:spPr>
          <a:xfrm rot="16200000">
            <a:off x="-38794" y="1564372"/>
            <a:ext cx="976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OVCAR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6130504-DE3C-E2C4-7094-61C8B4E649B4}"/>
              </a:ext>
            </a:extLst>
          </p:cNvPr>
          <p:cNvSpPr txBox="1"/>
          <p:nvPr/>
        </p:nvSpPr>
        <p:spPr>
          <a:xfrm rot="16200000">
            <a:off x="-295628" y="4330763"/>
            <a:ext cx="1490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/>
              <a:t>MDA-MB-436</a:t>
            </a:r>
            <a:endParaRPr lang="en-GB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0757062-9979-267E-CEC8-EE7A0AE4C5F1}"/>
              </a:ext>
            </a:extLst>
          </p:cNvPr>
          <p:cNvSpPr txBox="1"/>
          <p:nvPr/>
        </p:nvSpPr>
        <p:spPr>
          <a:xfrm>
            <a:off x="10112643" y="2155427"/>
            <a:ext cx="156247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ensitometry quantifying blots from Figure 2B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1AB902-EE35-1691-10D5-88C4AC20B2FD}"/>
              </a:ext>
            </a:extLst>
          </p:cNvPr>
          <p:cNvSpPr txBox="1"/>
          <p:nvPr/>
        </p:nvSpPr>
        <p:spPr>
          <a:xfrm>
            <a:off x="9561251" y="6381548"/>
            <a:ext cx="245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481035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The 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dai Banerji</dc:creator>
  <cp:lastModifiedBy>Udai Banerji</cp:lastModifiedBy>
  <cp:revision>4</cp:revision>
  <dcterms:created xsi:type="dcterms:W3CDTF">2024-01-21T17:32:18Z</dcterms:created>
  <dcterms:modified xsi:type="dcterms:W3CDTF">2024-02-20T18:14:51Z</dcterms:modified>
</cp:coreProperties>
</file>